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10458450" cy="864552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1" d="100"/>
          <a:sy n="61" d="100"/>
        </p:scale>
        <p:origin x="28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4384" y="1414905"/>
            <a:ext cx="8889683" cy="3009924"/>
          </a:xfrm>
        </p:spPr>
        <p:txBody>
          <a:bodyPr anchor="b"/>
          <a:lstStyle>
            <a:lvl1pPr algn="ctr">
              <a:defRPr sz="686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7306" y="4540903"/>
            <a:ext cx="7843838" cy="2087333"/>
          </a:xfrm>
        </p:spPr>
        <p:txBody>
          <a:bodyPr/>
          <a:lstStyle>
            <a:lvl1pPr marL="0" indent="0" algn="ctr">
              <a:buNone/>
              <a:defRPr sz="2745"/>
            </a:lvl1pPr>
            <a:lvl2pPr marL="522945" indent="0" algn="ctr">
              <a:buNone/>
              <a:defRPr sz="2288"/>
            </a:lvl2pPr>
            <a:lvl3pPr marL="1045891" indent="0" algn="ctr">
              <a:buNone/>
              <a:defRPr sz="2059"/>
            </a:lvl3pPr>
            <a:lvl4pPr marL="1568836" indent="0" algn="ctr">
              <a:buNone/>
              <a:defRPr sz="1830"/>
            </a:lvl4pPr>
            <a:lvl5pPr marL="2091781" indent="0" algn="ctr">
              <a:buNone/>
              <a:defRPr sz="1830"/>
            </a:lvl5pPr>
            <a:lvl6pPr marL="2614727" indent="0" algn="ctr">
              <a:buNone/>
              <a:defRPr sz="1830"/>
            </a:lvl6pPr>
            <a:lvl7pPr marL="3137672" indent="0" algn="ctr">
              <a:buNone/>
              <a:defRPr sz="1830"/>
            </a:lvl7pPr>
            <a:lvl8pPr marL="3660618" indent="0" algn="ctr">
              <a:buNone/>
              <a:defRPr sz="1830"/>
            </a:lvl8pPr>
            <a:lvl9pPr marL="4183563" indent="0" algn="ctr">
              <a:buNone/>
              <a:defRPr sz="183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2778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2094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84329" y="460294"/>
            <a:ext cx="2255103" cy="732668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9019" y="460294"/>
            <a:ext cx="6634579" cy="732668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161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847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3572" y="2155380"/>
            <a:ext cx="9020413" cy="3596298"/>
          </a:xfrm>
        </p:spPr>
        <p:txBody>
          <a:bodyPr anchor="b"/>
          <a:lstStyle>
            <a:lvl1pPr>
              <a:defRPr sz="686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3572" y="5785700"/>
            <a:ext cx="9020413" cy="1891208"/>
          </a:xfrm>
        </p:spPr>
        <p:txBody>
          <a:bodyPr/>
          <a:lstStyle>
            <a:lvl1pPr marL="0" indent="0">
              <a:buNone/>
              <a:defRPr sz="2745">
                <a:solidFill>
                  <a:schemeClr val="tx1"/>
                </a:solidFill>
              </a:defRPr>
            </a:lvl1pPr>
            <a:lvl2pPr marL="522945" indent="0">
              <a:buNone/>
              <a:defRPr sz="2288">
                <a:solidFill>
                  <a:schemeClr val="tx1">
                    <a:tint val="75000"/>
                  </a:schemeClr>
                </a:solidFill>
              </a:defRPr>
            </a:lvl2pPr>
            <a:lvl3pPr marL="1045891" indent="0">
              <a:buNone/>
              <a:defRPr sz="2059">
                <a:solidFill>
                  <a:schemeClr val="tx1">
                    <a:tint val="75000"/>
                  </a:schemeClr>
                </a:solidFill>
              </a:defRPr>
            </a:lvl3pPr>
            <a:lvl4pPr marL="1568836" indent="0">
              <a:buNone/>
              <a:defRPr sz="1830">
                <a:solidFill>
                  <a:schemeClr val="tx1">
                    <a:tint val="75000"/>
                  </a:schemeClr>
                </a:solidFill>
              </a:defRPr>
            </a:lvl4pPr>
            <a:lvl5pPr marL="2091781" indent="0">
              <a:buNone/>
              <a:defRPr sz="1830">
                <a:solidFill>
                  <a:schemeClr val="tx1">
                    <a:tint val="75000"/>
                  </a:schemeClr>
                </a:solidFill>
              </a:defRPr>
            </a:lvl5pPr>
            <a:lvl6pPr marL="2614727" indent="0">
              <a:buNone/>
              <a:defRPr sz="1830">
                <a:solidFill>
                  <a:schemeClr val="tx1">
                    <a:tint val="75000"/>
                  </a:schemeClr>
                </a:solidFill>
              </a:defRPr>
            </a:lvl6pPr>
            <a:lvl7pPr marL="3137672" indent="0">
              <a:buNone/>
              <a:defRPr sz="1830">
                <a:solidFill>
                  <a:schemeClr val="tx1">
                    <a:tint val="75000"/>
                  </a:schemeClr>
                </a:solidFill>
              </a:defRPr>
            </a:lvl7pPr>
            <a:lvl8pPr marL="3660618" indent="0">
              <a:buNone/>
              <a:defRPr sz="1830">
                <a:solidFill>
                  <a:schemeClr val="tx1">
                    <a:tint val="75000"/>
                  </a:schemeClr>
                </a:solidFill>
              </a:defRPr>
            </a:lvl8pPr>
            <a:lvl9pPr marL="4183563" indent="0">
              <a:buNone/>
              <a:defRPr sz="18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7448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9019" y="2301471"/>
            <a:ext cx="4444841" cy="5485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94590" y="2301471"/>
            <a:ext cx="4444841" cy="5485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71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0381" y="460296"/>
            <a:ext cx="9020413" cy="16710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0382" y="2119355"/>
            <a:ext cx="4424414" cy="1038663"/>
          </a:xfrm>
        </p:spPr>
        <p:txBody>
          <a:bodyPr anchor="b"/>
          <a:lstStyle>
            <a:lvl1pPr marL="0" indent="0">
              <a:buNone/>
              <a:defRPr sz="2745" b="1"/>
            </a:lvl1pPr>
            <a:lvl2pPr marL="522945" indent="0">
              <a:buNone/>
              <a:defRPr sz="2288" b="1"/>
            </a:lvl2pPr>
            <a:lvl3pPr marL="1045891" indent="0">
              <a:buNone/>
              <a:defRPr sz="2059" b="1"/>
            </a:lvl3pPr>
            <a:lvl4pPr marL="1568836" indent="0">
              <a:buNone/>
              <a:defRPr sz="1830" b="1"/>
            </a:lvl4pPr>
            <a:lvl5pPr marL="2091781" indent="0">
              <a:buNone/>
              <a:defRPr sz="1830" b="1"/>
            </a:lvl5pPr>
            <a:lvl6pPr marL="2614727" indent="0">
              <a:buNone/>
              <a:defRPr sz="1830" b="1"/>
            </a:lvl6pPr>
            <a:lvl7pPr marL="3137672" indent="0">
              <a:buNone/>
              <a:defRPr sz="1830" b="1"/>
            </a:lvl7pPr>
            <a:lvl8pPr marL="3660618" indent="0">
              <a:buNone/>
              <a:defRPr sz="1830" b="1"/>
            </a:lvl8pPr>
            <a:lvl9pPr marL="4183563" indent="0">
              <a:buNone/>
              <a:defRPr sz="183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0382" y="3158018"/>
            <a:ext cx="4424414" cy="464496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94591" y="2119355"/>
            <a:ext cx="4446203" cy="1038663"/>
          </a:xfrm>
        </p:spPr>
        <p:txBody>
          <a:bodyPr anchor="b"/>
          <a:lstStyle>
            <a:lvl1pPr marL="0" indent="0">
              <a:buNone/>
              <a:defRPr sz="2745" b="1"/>
            </a:lvl1pPr>
            <a:lvl2pPr marL="522945" indent="0">
              <a:buNone/>
              <a:defRPr sz="2288" b="1"/>
            </a:lvl2pPr>
            <a:lvl3pPr marL="1045891" indent="0">
              <a:buNone/>
              <a:defRPr sz="2059" b="1"/>
            </a:lvl3pPr>
            <a:lvl4pPr marL="1568836" indent="0">
              <a:buNone/>
              <a:defRPr sz="1830" b="1"/>
            </a:lvl4pPr>
            <a:lvl5pPr marL="2091781" indent="0">
              <a:buNone/>
              <a:defRPr sz="1830" b="1"/>
            </a:lvl5pPr>
            <a:lvl6pPr marL="2614727" indent="0">
              <a:buNone/>
              <a:defRPr sz="1830" b="1"/>
            </a:lvl6pPr>
            <a:lvl7pPr marL="3137672" indent="0">
              <a:buNone/>
              <a:defRPr sz="1830" b="1"/>
            </a:lvl7pPr>
            <a:lvl8pPr marL="3660618" indent="0">
              <a:buNone/>
              <a:defRPr sz="1830" b="1"/>
            </a:lvl8pPr>
            <a:lvl9pPr marL="4183563" indent="0">
              <a:buNone/>
              <a:defRPr sz="183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94591" y="3158018"/>
            <a:ext cx="4446203" cy="464496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2725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6315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8837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0381" y="576368"/>
            <a:ext cx="3373122" cy="2017289"/>
          </a:xfrm>
        </p:spPr>
        <p:txBody>
          <a:bodyPr anchor="b"/>
          <a:lstStyle>
            <a:lvl1pPr>
              <a:defRPr sz="36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46204" y="1244798"/>
            <a:ext cx="5294590" cy="6143926"/>
          </a:xfrm>
        </p:spPr>
        <p:txBody>
          <a:bodyPr/>
          <a:lstStyle>
            <a:lvl1pPr>
              <a:defRPr sz="3660"/>
            </a:lvl1pPr>
            <a:lvl2pPr>
              <a:defRPr sz="3203"/>
            </a:lvl2pPr>
            <a:lvl3pPr>
              <a:defRPr sz="2745"/>
            </a:lvl3pPr>
            <a:lvl4pPr>
              <a:defRPr sz="2288"/>
            </a:lvl4pPr>
            <a:lvl5pPr>
              <a:defRPr sz="2288"/>
            </a:lvl5pPr>
            <a:lvl6pPr>
              <a:defRPr sz="2288"/>
            </a:lvl6pPr>
            <a:lvl7pPr>
              <a:defRPr sz="2288"/>
            </a:lvl7pPr>
            <a:lvl8pPr>
              <a:defRPr sz="2288"/>
            </a:lvl8pPr>
            <a:lvl9pPr>
              <a:defRPr sz="2288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0381" y="2593658"/>
            <a:ext cx="3373122" cy="4805071"/>
          </a:xfrm>
        </p:spPr>
        <p:txBody>
          <a:bodyPr/>
          <a:lstStyle>
            <a:lvl1pPr marL="0" indent="0">
              <a:buNone/>
              <a:defRPr sz="1830"/>
            </a:lvl1pPr>
            <a:lvl2pPr marL="522945" indent="0">
              <a:buNone/>
              <a:defRPr sz="1601"/>
            </a:lvl2pPr>
            <a:lvl3pPr marL="1045891" indent="0">
              <a:buNone/>
              <a:defRPr sz="1373"/>
            </a:lvl3pPr>
            <a:lvl4pPr marL="1568836" indent="0">
              <a:buNone/>
              <a:defRPr sz="1144"/>
            </a:lvl4pPr>
            <a:lvl5pPr marL="2091781" indent="0">
              <a:buNone/>
              <a:defRPr sz="1144"/>
            </a:lvl5pPr>
            <a:lvl6pPr marL="2614727" indent="0">
              <a:buNone/>
              <a:defRPr sz="1144"/>
            </a:lvl6pPr>
            <a:lvl7pPr marL="3137672" indent="0">
              <a:buNone/>
              <a:defRPr sz="1144"/>
            </a:lvl7pPr>
            <a:lvl8pPr marL="3660618" indent="0">
              <a:buNone/>
              <a:defRPr sz="1144"/>
            </a:lvl8pPr>
            <a:lvl9pPr marL="4183563" indent="0">
              <a:buNone/>
              <a:defRPr sz="114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058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0381" y="576368"/>
            <a:ext cx="3373122" cy="2017289"/>
          </a:xfrm>
        </p:spPr>
        <p:txBody>
          <a:bodyPr anchor="b"/>
          <a:lstStyle>
            <a:lvl1pPr>
              <a:defRPr sz="36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46204" y="1244798"/>
            <a:ext cx="5294590" cy="6143926"/>
          </a:xfrm>
        </p:spPr>
        <p:txBody>
          <a:bodyPr anchor="t"/>
          <a:lstStyle>
            <a:lvl1pPr marL="0" indent="0">
              <a:buNone/>
              <a:defRPr sz="3660"/>
            </a:lvl1pPr>
            <a:lvl2pPr marL="522945" indent="0">
              <a:buNone/>
              <a:defRPr sz="3203"/>
            </a:lvl2pPr>
            <a:lvl3pPr marL="1045891" indent="0">
              <a:buNone/>
              <a:defRPr sz="2745"/>
            </a:lvl3pPr>
            <a:lvl4pPr marL="1568836" indent="0">
              <a:buNone/>
              <a:defRPr sz="2288"/>
            </a:lvl4pPr>
            <a:lvl5pPr marL="2091781" indent="0">
              <a:buNone/>
              <a:defRPr sz="2288"/>
            </a:lvl5pPr>
            <a:lvl6pPr marL="2614727" indent="0">
              <a:buNone/>
              <a:defRPr sz="2288"/>
            </a:lvl6pPr>
            <a:lvl7pPr marL="3137672" indent="0">
              <a:buNone/>
              <a:defRPr sz="2288"/>
            </a:lvl7pPr>
            <a:lvl8pPr marL="3660618" indent="0">
              <a:buNone/>
              <a:defRPr sz="2288"/>
            </a:lvl8pPr>
            <a:lvl9pPr marL="4183563" indent="0">
              <a:buNone/>
              <a:defRPr sz="2288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0381" y="2593658"/>
            <a:ext cx="3373122" cy="4805071"/>
          </a:xfrm>
        </p:spPr>
        <p:txBody>
          <a:bodyPr/>
          <a:lstStyle>
            <a:lvl1pPr marL="0" indent="0">
              <a:buNone/>
              <a:defRPr sz="1830"/>
            </a:lvl1pPr>
            <a:lvl2pPr marL="522945" indent="0">
              <a:buNone/>
              <a:defRPr sz="1601"/>
            </a:lvl2pPr>
            <a:lvl3pPr marL="1045891" indent="0">
              <a:buNone/>
              <a:defRPr sz="1373"/>
            </a:lvl3pPr>
            <a:lvl4pPr marL="1568836" indent="0">
              <a:buNone/>
              <a:defRPr sz="1144"/>
            </a:lvl4pPr>
            <a:lvl5pPr marL="2091781" indent="0">
              <a:buNone/>
              <a:defRPr sz="1144"/>
            </a:lvl5pPr>
            <a:lvl6pPr marL="2614727" indent="0">
              <a:buNone/>
              <a:defRPr sz="1144"/>
            </a:lvl6pPr>
            <a:lvl7pPr marL="3137672" indent="0">
              <a:buNone/>
              <a:defRPr sz="1144"/>
            </a:lvl7pPr>
            <a:lvl8pPr marL="3660618" indent="0">
              <a:buNone/>
              <a:defRPr sz="1144"/>
            </a:lvl8pPr>
            <a:lvl9pPr marL="4183563" indent="0">
              <a:buNone/>
              <a:defRPr sz="114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3087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9019" y="460296"/>
            <a:ext cx="9020413" cy="1671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9019" y="2301471"/>
            <a:ext cx="9020413" cy="54855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9019" y="8013123"/>
            <a:ext cx="2353151" cy="4602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64362" y="8013123"/>
            <a:ext cx="3529727" cy="4602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86280" y="8013123"/>
            <a:ext cx="2353151" cy="4602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389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045891" rtl="0" eaLnBrk="1" latinLnBrk="0" hangingPunct="1">
        <a:lnSpc>
          <a:spcPct val="90000"/>
        </a:lnSpc>
        <a:spcBef>
          <a:spcPct val="0"/>
        </a:spcBef>
        <a:buNone/>
        <a:defRPr sz="50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1473" indent="-261473" algn="l" defTabSz="1045891" rtl="0" eaLnBrk="1" latinLnBrk="0" hangingPunct="1">
        <a:lnSpc>
          <a:spcPct val="90000"/>
        </a:lnSpc>
        <a:spcBef>
          <a:spcPts val="1144"/>
        </a:spcBef>
        <a:buFont typeface="Arial" panose="020B0604020202020204" pitchFamily="34" charset="0"/>
        <a:buChar char="•"/>
        <a:defRPr sz="3203" kern="1200">
          <a:solidFill>
            <a:schemeClr val="tx1"/>
          </a:solidFill>
          <a:latin typeface="+mn-lt"/>
          <a:ea typeface="+mn-ea"/>
          <a:cs typeface="+mn-cs"/>
        </a:defRPr>
      </a:lvl1pPr>
      <a:lvl2pPr marL="784418" indent="-261473" algn="l" defTabSz="1045891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745" kern="1200">
          <a:solidFill>
            <a:schemeClr val="tx1"/>
          </a:solidFill>
          <a:latin typeface="+mn-lt"/>
          <a:ea typeface="+mn-ea"/>
          <a:cs typeface="+mn-cs"/>
        </a:defRPr>
      </a:lvl2pPr>
      <a:lvl3pPr marL="1307363" indent="-261473" algn="l" defTabSz="1045891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288" kern="1200">
          <a:solidFill>
            <a:schemeClr val="tx1"/>
          </a:solidFill>
          <a:latin typeface="+mn-lt"/>
          <a:ea typeface="+mn-ea"/>
          <a:cs typeface="+mn-cs"/>
        </a:defRPr>
      </a:lvl3pPr>
      <a:lvl4pPr marL="1830309" indent="-261473" algn="l" defTabSz="1045891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59" kern="1200">
          <a:solidFill>
            <a:schemeClr val="tx1"/>
          </a:solidFill>
          <a:latin typeface="+mn-lt"/>
          <a:ea typeface="+mn-ea"/>
          <a:cs typeface="+mn-cs"/>
        </a:defRPr>
      </a:lvl4pPr>
      <a:lvl5pPr marL="2353254" indent="-261473" algn="l" defTabSz="1045891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59" kern="1200">
          <a:solidFill>
            <a:schemeClr val="tx1"/>
          </a:solidFill>
          <a:latin typeface="+mn-lt"/>
          <a:ea typeface="+mn-ea"/>
          <a:cs typeface="+mn-cs"/>
        </a:defRPr>
      </a:lvl5pPr>
      <a:lvl6pPr marL="2876199" indent="-261473" algn="l" defTabSz="1045891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59" kern="1200">
          <a:solidFill>
            <a:schemeClr val="tx1"/>
          </a:solidFill>
          <a:latin typeface="+mn-lt"/>
          <a:ea typeface="+mn-ea"/>
          <a:cs typeface="+mn-cs"/>
        </a:defRPr>
      </a:lvl6pPr>
      <a:lvl7pPr marL="3399145" indent="-261473" algn="l" defTabSz="1045891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59" kern="1200">
          <a:solidFill>
            <a:schemeClr val="tx1"/>
          </a:solidFill>
          <a:latin typeface="+mn-lt"/>
          <a:ea typeface="+mn-ea"/>
          <a:cs typeface="+mn-cs"/>
        </a:defRPr>
      </a:lvl7pPr>
      <a:lvl8pPr marL="3922090" indent="-261473" algn="l" defTabSz="1045891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59" kern="1200">
          <a:solidFill>
            <a:schemeClr val="tx1"/>
          </a:solidFill>
          <a:latin typeface="+mn-lt"/>
          <a:ea typeface="+mn-ea"/>
          <a:cs typeface="+mn-cs"/>
        </a:defRPr>
      </a:lvl8pPr>
      <a:lvl9pPr marL="4445036" indent="-261473" algn="l" defTabSz="1045891" rtl="0" eaLnBrk="1" latinLnBrk="0" hangingPunct="1">
        <a:lnSpc>
          <a:spcPct val="90000"/>
        </a:lnSpc>
        <a:spcBef>
          <a:spcPts val="572"/>
        </a:spcBef>
        <a:buFont typeface="Arial" panose="020B0604020202020204" pitchFamily="34" charset="0"/>
        <a:buChar char="•"/>
        <a:defRPr sz="20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1pPr>
      <a:lvl2pPr marL="522945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2pPr>
      <a:lvl3pPr marL="1045891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3pPr>
      <a:lvl4pPr marL="1568836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4pPr>
      <a:lvl5pPr marL="2091781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5pPr>
      <a:lvl6pPr marL="2614727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6pPr>
      <a:lvl7pPr marL="3137672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7pPr>
      <a:lvl8pPr marL="3660618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8pPr>
      <a:lvl9pPr marL="4183563" algn="l" defTabSz="1045891" rtl="0" eaLnBrk="1" latinLnBrk="0" hangingPunct="1">
        <a:defRPr sz="20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75700" y="1115415"/>
            <a:ext cx="9977948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ine Resource 3. </a:t>
            </a:r>
            <a:r>
              <a:rPr lang="en-GB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equency and severity of back pain, limitation of activities and days in bed due to back pain in the past month (Total Study Cohort)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8957505"/>
              </p:ext>
            </p:extLst>
          </p:nvPr>
        </p:nvGraphicFramePr>
        <p:xfrm>
          <a:off x="241829" y="1429662"/>
          <a:ext cx="9974792" cy="6475755"/>
        </p:xfrm>
        <a:graphic>
          <a:graphicData uri="http://schemas.openxmlformats.org/drawingml/2006/table">
            <a:tbl>
              <a:tblPr firstRow="1" firstCol="1" bandRow="1"/>
              <a:tblGrid>
                <a:gridCol w="206286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1907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6659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1368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0065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2891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857171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60131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885429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970204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810073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</a:tblGrid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riabl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uring teriparatide treatment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fter teriparatide discontinued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 months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in </a:t>
                      </a:r>
                      <a:r>
                        <a:rPr lang="en-US" sz="900" b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requency</a:t>
                      </a:r>
                      <a:r>
                        <a:rPr lang="en-US" sz="900" baseline="30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3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2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9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2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5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pain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0 (9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4 (13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9 (16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3 (20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1 (24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4 (28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0 (35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5 (23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7 (41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in (any frequency), </a:t>
                      </a: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91 (90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28 (86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2 (83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2 (79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23 (75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60 (71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2 (64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2 (77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15 (58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ange from </a:t>
                      </a:r>
                      <a:r>
                        <a:rPr lang="en-US" sz="900" b="1" i="1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aseline</a:t>
                      </a:r>
                      <a:r>
                        <a:rPr lang="en-US" sz="900" b="1" i="1" baseline="30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2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9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2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5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3665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mprovement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 (8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7 (11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4 (15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3 (19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3 (22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9 (29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8 (17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1 (35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3665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change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5 (87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7 (83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34 (79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31 (76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79 (73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2 (66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8 (80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31 (61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3665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orsening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 (4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 (4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 (4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 (4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 (3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1 (4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 (2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 (3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ain severity</a:t>
                      </a:r>
                      <a:r>
                        <a:rPr lang="en-US" sz="9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4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8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5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73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4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6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1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nor pain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9 (19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60 (38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6 (46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68 (52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0 (53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7 (55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3 (64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0 (48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5 (67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oderate pain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1 (47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9 (46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98 (43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9 (39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1 (39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87 (37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4 (29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8 (41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5 (26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vere pain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1 (33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3 (14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6 (10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6 (8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1 (7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 (6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 (6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 (10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 (5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ange from baseline</a:t>
                      </a:r>
                      <a:r>
                        <a:rPr lang="en-US" sz="900" b="1" i="1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1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13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4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9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mprovement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1 (37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16 (46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3 (53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3 (55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0 (58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0 (63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2 (46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5 (63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change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4 (57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1 (48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8 (42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8 (39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5 (37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3 (32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8 (48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5 (34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1760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orsening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1 (5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 (4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 (4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2 (5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 (4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 (3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 (4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 (2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imitation of activities</a:t>
                      </a:r>
                      <a:r>
                        <a:rPr lang="en-US" sz="900" b="1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5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0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8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9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4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9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ne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8 (19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4 (33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5 (36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5 (40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9 (41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9 (43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2 (55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 (29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6 (57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nor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6 (20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36 (28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0 (30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7 (29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3 (30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9 (28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8 (24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9 (35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3 (27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oderate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21 (35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3 (26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9 (25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5 (23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2 (22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1 (21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6 (17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2 (28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 (12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vere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3 (24.9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9 (11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3 (7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2 (6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6 (5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1 (6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 (3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 (6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 (2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hange from baseline</a:t>
                      </a:r>
                      <a:r>
                        <a:rPr lang="en-US" sz="900" b="1" i="1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0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5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83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75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17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7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3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3665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mprovement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78 (40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63 (48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6 (53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44 (55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6 (53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9 (56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2 (54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0 (59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3665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change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9 (49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74 (41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4 (37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0 (35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5 (37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8 (37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 (33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3 (33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0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 marL="113665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Worsening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3 (9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 (9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3 (9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1 (8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6 (9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7 (5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 (12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 (6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1"/>
                  </a:ext>
                </a:extLst>
              </a:tr>
              <a:tr h="196023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ays in bed due to back pain</a:t>
                      </a:r>
                      <a:r>
                        <a:rPr lang="en-US" sz="900" b="1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2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7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2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08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49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41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86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9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4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2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3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ne, </a:t>
                      </a: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13 (82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4 (90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35 (94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75 (93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86 (94.7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43 (95.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4 (93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7 (95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1 (92.8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4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 least one, </a:t>
                      </a: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%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9 (17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 (9.6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3 (6.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4 (6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5 (5.3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 (4.9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 (6.5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 (4.4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1 (7.2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5"/>
                  </a:ext>
                </a:extLst>
              </a:tr>
              <a:tr h="174437"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dian (Q1, Q3)</a:t>
                      </a:r>
                      <a:r>
                        <a:rPr lang="en-US" sz="900" baseline="30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0 (1, 3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0 (1, 31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0 (1, 3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0 (1, 31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0 (1, 6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0 (1, 2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0 (1, 1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0 (1, 20)</a:t>
                      </a:r>
                      <a:endParaRPr lang="en-GB" sz="9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295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0 (1, 20)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35031" marR="35031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6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75700" y="7908256"/>
            <a:ext cx="9977948" cy="58477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8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mber of evaluable patients, </a:t>
            </a:r>
            <a:r>
              <a:rPr lang="en-GB" sz="8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umber of patients with characteristic</a:t>
            </a:r>
          </a:p>
          <a:p>
            <a:pPr>
              <a:defRPr/>
            </a:pPr>
            <a:r>
              <a:rPr lang="en-GB" sz="800" kern="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uring past month</a:t>
            </a:r>
          </a:p>
          <a:p>
            <a:pPr>
              <a:defRPr/>
            </a:pPr>
            <a:r>
              <a:rPr lang="en-GB" sz="800" kern="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 each visit, significantly more patients improved than worsened (</a:t>
            </a:r>
            <a:r>
              <a:rPr lang="en-GB" sz="8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01; Wilcoxon signed rank test) </a:t>
            </a:r>
          </a:p>
          <a:p>
            <a:pPr>
              <a:defRPr/>
            </a:pPr>
            <a:r>
              <a:rPr lang="en-GB" sz="800" kern="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or patients with at least one day in bed due to back pa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D8E8364C-D6DF-47F8-83D6-A44680161DA5}"/>
              </a:ext>
            </a:extLst>
          </p:cNvPr>
          <p:cNvSpPr txBox="1"/>
          <p:nvPr/>
        </p:nvSpPr>
        <p:spPr>
          <a:xfrm>
            <a:off x="175700" y="189475"/>
            <a:ext cx="9977948" cy="784830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Effectiveness of teriparatide in patients with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osteoporosis in clinical practice: 42-month results during and after discontinuation of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treatment from the European Extended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orsteo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Observational Study (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xFOS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Calcified Tissue International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N. Napoli, B. L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angdahl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Ö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junggre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E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espessaille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G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apetano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ocja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Nikolic, P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Eike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H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ett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Moll, E. Lindh, F. Marin</a:t>
            </a:r>
          </a:p>
          <a:p>
            <a:pPr>
              <a:defRPr/>
            </a:pP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sponding author: Nicola Napoli,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niversity Campus Bio-Medico, Rome, Italy; e-mail: </a:t>
            </a: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Napoli@unicampus.it</a:t>
            </a:r>
          </a:p>
        </p:txBody>
      </p:sp>
    </p:spTree>
    <p:extLst>
      <p:ext uri="{BB962C8B-B14F-4D97-AF65-F5344CB8AC3E}">
        <p14:creationId xmlns:p14="http://schemas.microsoft.com/office/powerpoint/2010/main" val="363528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142</Words>
  <Application>Microsoft Office PowerPoint</Application>
  <PresentationFormat>Custom</PresentationFormat>
  <Paragraphs>4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x</dc:creator>
  <cp:lastModifiedBy>Rx</cp:lastModifiedBy>
  <cp:revision>12</cp:revision>
  <dcterms:created xsi:type="dcterms:W3CDTF">2017-07-05T13:17:28Z</dcterms:created>
  <dcterms:modified xsi:type="dcterms:W3CDTF">2018-01-18T14:15:24Z</dcterms:modified>
</cp:coreProperties>
</file>